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8"/>
    <p:restoredTop sz="94704"/>
  </p:normalViewPr>
  <p:slideViewPr>
    <p:cSldViewPr snapToGrid="0" snapToObjects="1">
      <p:cViewPr varScale="1">
        <p:scale>
          <a:sx n="90" d="100"/>
          <a:sy n="90" d="100"/>
        </p:scale>
        <p:origin x="11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573610-195C-DF42-8369-44654A7207D0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91CBCC-9C75-654F-9D5F-0DF8574DA0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69686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91CBCC-9C75-654F-9D5F-0DF8574DA01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84957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CBDFF-DD18-E041-865A-8D4071B67947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9893-C911-AE48-A488-038D8487B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1204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CBDFF-DD18-E041-865A-8D4071B67947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9893-C911-AE48-A488-038D8487B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3784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CBDFF-DD18-E041-865A-8D4071B67947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9893-C911-AE48-A488-038D8487B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62930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CBDFF-DD18-E041-865A-8D4071B67947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9893-C911-AE48-A488-038D8487B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40634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CBDFF-DD18-E041-865A-8D4071B67947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9893-C911-AE48-A488-038D8487B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5373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CBDFF-DD18-E041-865A-8D4071B67947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9893-C911-AE48-A488-038D8487B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16702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CBDFF-DD18-E041-865A-8D4071B67947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9893-C911-AE48-A488-038D8487B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62982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CBDFF-DD18-E041-865A-8D4071B67947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9893-C911-AE48-A488-038D8487B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0441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CBDFF-DD18-E041-865A-8D4071B67947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9893-C911-AE48-A488-038D8487B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25044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CBDFF-DD18-E041-865A-8D4071B67947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9893-C911-AE48-A488-038D8487B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50770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7CBDFF-DD18-E041-865A-8D4071B67947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49893-C911-AE48-A488-038D8487B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6885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7CBDFF-DD18-E041-865A-8D4071B67947}" type="datetimeFigureOut">
              <a:rPr kumimoji="1" lang="ja-JP" altLang="en-US" smtClean="0"/>
              <a:t>2022/1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D49893-C911-AE48-A488-038D8487B21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96905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1.png"/><Relationship Id="rId4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16200439662539">
            <a:hlinkClick r:id="" action="ppaction://media"/>
            <a:extLst>
              <a:ext uri="{FF2B5EF4-FFF2-40B4-BE49-F238E27FC236}">
                <a16:creationId xmlns:a16="http://schemas.microsoft.com/office/drawing/2014/main" id="{6077C2EA-D223-1A47-8361-861063A35497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1641096" y="398575"/>
            <a:ext cx="5687752" cy="4540643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DC224F3-CADF-C64E-BC2B-0C4C417FCD91}"/>
              </a:ext>
            </a:extLst>
          </p:cNvPr>
          <p:cNvSpPr txBox="1"/>
          <p:nvPr/>
        </p:nvSpPr>
        <p:spPr>
          <a:xfrm>
            <a:off x="536163" y="5605990"/>
            <a:ext cx="8258864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1: 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yotube contraction by electrical stimulation. Myotubes were electrically </a:t>
            </a:r>
          </a:p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imulated (30 mA at 1Hz for 15 </a:t>
            </a:r>
            <a:r>
              <a:rPr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s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 985 </a:t>
            </a:r>
            <a:r>
              <a:rPr lang="en-US" altLang="ja-JP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s</a:t>
            </a:r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ervals) with an electrical pulse generator (ITO Co., </a:t>
            </a:r>
          </a:p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td, Saitama, Japan)  to confirm differentiation. Separately plated cells were used to confirm contraction </a:t>
            </a:r>
          </a:p>
          <a:p>
            <a:r>
              <a:rPr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he cells used for the experiments were not electrically stimulated.</a:t>
            </a:r>
            <a:endParaRPr kumimoji="1" lang="ja-JP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114839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625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 mute="1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67</Words>
  <Application>Microsoft Macintosh PowerPoint</Application>
  <PresentationFormat>画面に合わせる (4:3)</PresentationFormat>
  <Paragraphs>5</Paragraphs>
  <Slides>1</Slides>
  <Notes>1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Microsoft Office User</cp:lastModifiedBy>
  <cp:revision>5</cp:revision>
  <dcterms:created xsi:type="dcterms:W3CDTF">2022-07-17T17:36:11Z</dcterms:created>
  <dcterms:modified xsi:type="dcterms:W3CDTF">2022-11-12T03:01:37Z</dcterms:modified>
</cp:coreProperties>
</file>